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60" r:id="rId1"/>
  </p:sldMasterIdLst>
  <p:sldIdLst>
    <p:sldId id="256" r:id="rId2"/>
  </p:sldIdLst>
  <p:sldSz cx="12192000" cy="6858000"/>
  <p:notesSz cx="6858000" cy="9144000"/>
  <p:defaultTextStyle>
    <a:defPPr>
      <a:defRPr lang="it-GB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431"/>
    <p:restoredTop sz="95196"/>
  </p:normalViewPr>
  <p:slideViewPr>
    <p:cSldViewPr snapToGrid="0">
      <p:cViewPr varScale="1">
        <p:scale>
          <a:sx n="74" d="100"/>
          <a:sy n="74" d="100"/>
        </p:scale>
        <p:origin x="176" y="3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81C8FF3-2C59-8D26-0693-BD7C215AFF0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2AF5AC7D-F671-006D-DB26-F81F96D4B5E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7C05759-E619-6696-4B24-81413D1588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B3A824-1A51-4B26-AD58-A6D8E14F6C04}" type="datetimeFigureOut">
              <a:rPr lang="en-US" smtClean="0"/>
              <a:t>12/4/23</a:t>
            </a:fld>
            <a:endParaRPr lang="en-US" dirty="0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0443E21-9003-3C0A-C8AD-C33F7A5AEF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E4DAE85-03DF-1815-8DC8-C745820886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N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43914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CB6D3FA-38E6-A57C-0925-364A43A7D0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83C40919-812E-EFCC-5636-FF45C8CC8F2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F6C9F90-A94B-8A70-70AB-5CD9C8F42A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57E33E-8B18-4087-B112-809917729534}" type="datetimeFigureOut">
              <a:rPr lang="en-US" smtClean="0"/>
              <a:t>12/4/23</a:t>
            </a:fld>
            <a:endParaRPr lang="en-US" dirty="0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068CED0-780C-2879-3343-6F8C6A020A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C7E886E-FAB3-0E99-6CCC-2567BE6D2D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N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190087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5E1CBE02-CD76-3496-42AA-0086FDACB18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E929168A-5D2B-8826-FA09-3BBB0632B6A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A7C8EA4-673B-A0BF-E40E-ADB70CA9AF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C1C18-307B-4F68-A007-B5B542270E8D}" type="datetimeFigureOut">
              <a:rPr lang="en-US" smtClean="0"/>
              <a:t>12/4/23</a:t>
            </a:fld>
            <a:endParaRPr lang="en-US" dirty="0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15B0059-0A95-8A46-DF89-8F3EBFB485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F5F8159-1748-3606-C52A-C5BA48BFB1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pPr/>
              <a:t>‹N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37184324"/>
      </p:ext>
    </p:extLst>
  </p:cSld>
  <p:clrMapOvr>
    <a:masterClrMapping/>
  </p:clrMapOvr>
  <p:hf sldNum="0" hdr="0" ftr="0" dt="0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7481E22-5170-B4B4-C7F9-EE090B37A9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8AFF9FA4-50F6-8FBD-786A-9CC346CD47F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5B02090-C2C5-2C01-0106-DD820EE909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D162C4-EDD9-4389-A98B-B87ECEA2A816}" type="datetimeFigureOut">
              <a:rPr lang="en-US" smtClean="0"/>
              <a:t>12/4/23</a:t>
            </a:fld>
            <a:endParaRPr lang="en-US" dirty="0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CF9071C-443C-99C1-0129-3DF3A10FBE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113F170-B432-4EAF-C96B-7591B858E3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N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422413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11D48C6-D648-23C1-D3E1-AA0B93873E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980E4BB1-6CA0-A6D7-8D9F-6567EB14BE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EAFED79-E61D-7FC7-CFF6-A0A858098B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5059C3-6A89-4494-99FF-5A4D6FFD50EB}" type="datetimeFigureOut">
              <a:rPr lang="en-US" smtClean="0"/>
              <a:t>12/4/23</a:t>
            </a:fld>
            <a:endParaRPr lang="en-US" dirty="0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AD12FF1-5B09-7F7F-B20B-45CB6663C8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694E8E1-9AD7-FA78-ED1B-9FFAF8D4E1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N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485751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2ACDC0F-45EC-8001-B0AF-6446A166E3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E656CF8C-B94B-9BE7-80D8-22C2B63D0F0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343CFBEB-1836-80F1-F68D-1F52D43A435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9292A8BA-947F-D947-14F4-D4400D3890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954B2F-12DE-47F5-8894-472B206D2E1E}" type="datetimeFigureOut">
              <a:rPr lang="en-US" smtClean="0"/>
              <a:t>12/4/23</a:t>
            </a:fld>
            <a:endParaRPr lang="en-US" dirty="0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8423BCC5-EB48-E53B-6247-56245F939A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6C7135B5-765D-7718-934D-2CCA880503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N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455471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E8284D1-2AF3-10BB-0515-193D04BEE3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FEF2CABA-1863-5044-8DF3-28940A5127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39DBB9A3-FDAF-7D95-99C9-9869A74EAC6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12B92966-90FF-2F1C-25CA-5C91E1FFD27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C83D761F-6E26-0EAA-DB79-EEF81D29F7F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EC56C51E-D942-F7E0-9C2E-E217723D95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0E46F-7819-4ACF-B48B-48222C2ACC88}" type="datetimeFigureOut">
              <a:rPr lang="en-US" smtClean="0"/>
              <a:t>12/4/23</a:t>
            </a:fld>
            <a:endParaRPr lang="en-US" dirty="0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B7A1833E-70F8-F6D5-846E-E6DBD288F6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EC6F3B73-EA71-0330-ED17-E665BFA2E8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N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204971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362CC85-5307-818A-FCB6-D26A326F16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FC8B856F-A11B-4BB9-E37E-8DED23A7CF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F3416-4057-4DAA-829D-4CA07428D088}" type="datetimeFigureOut">
              <a:rPr lang="en-US" smtClean="0"/>
              <a:t>12/4/23</a:t>
            </a:fld>
            <a:endParaRPr lang="en-US" dirty="0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86712D0D-2DD2-D5FD-73B2-D9D7573706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D07D2073-7BE6-7D7A-A90E-BF9030E925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N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328534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D390AE69-9D71-C783-FA42-7B03D2D64E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D9284-D300-4297-87F7-E791DCC15DB1}" type="datetimeFigureOut">
              <a:rPr lang="en-US" smtClean="0"/>
              <a:t>12/4/23</a:t>
            </a:fld>
            <a:endParaRPr lang="en-US" dirty="0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01FD888C-1D9E-3BB8-4BBB-1A38D2CD58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9E5BD2CC-BB12-E520-7A7B-BAA3CFBE02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N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232199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F35DCF9-02AD-1544-9818-A4C1E13DBD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E2DFDD9B-AD57-F059-FC4E-A32449420E8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127818C8-AD2F-7CA5-116F-F022BF1F66B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9986DA38-C856-9E84-EF1F-3BFF6ADBC3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525BB-DA17-4BA0-B3C8-3AC3ABC827E6}" type="datetimeFigureOut">
              <a:rPr lang="en-US" smtClean="0"/>
              <a:t>12/4/23</a:t>
            </a:fld>
            <a:endParaRPr lang="en-US" dirty="0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83A49C4C-02E1-D8FF-6305-5646E86EA2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84886338-2AD8-7633-8C08-F1145F6438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N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740948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D93FE42-136B-617A-4F32-CB3C48177B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3F30934F-CFCB-F741-FC1F-FEB3BE52F6F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CB5356CD-3E46-A7D2-F265-11192EB5E37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AE1746E0-BF3A-DDCB-FCEB-9401B1D072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6C4C9A-3960-41CF-A4E9-2A8FB932454B}" type="datetimeFigureOut">
              <a:rPr lang="en-US" smtClean="0"/>
              <a:t>12/4/23</a:t>
            </a:fld>
            <a:endParaRPr lang="en-US" dirty="0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2BDA28A3-F4B7-6B48-41C5-5B33B8D697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C9FBF2FC-EB44-0D0C-1858-551752F9B5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N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618371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0012E155-764B-D9FB-BAED-6D1D1CB274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CD49814A-B40C-1198-B6D7-BE7AEE814C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AD32C9E-74EC-F860-3424-7C987675124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BC1C18-307B-4F68-A007-B5B542270E8D}" type="datetimeFigureOut">
              <a:rPr lang="en-US" smtClean="0"/>
              <a:t>12/4/23</a:t>
            </a:fld>
            <a:endParaRPr lang="en-US" dirty="0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9BE829E-E778-FDB8-CFD5-C75F1AD0719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AE01001-B9AA-12FA-61D4-9652ECA1CD4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22F896-40B5-4ADD-8801-0D06FADFA095}" type="slidenum">
              <a:rPr lang="en-US" smtClean="0"/>
              <a:pPr/>
              <a:t>‹N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613626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sldNum="0"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GB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116572B7-8CEF-ADEC-B6C5-4D410829FA24}"/>
              </a:ext>
            </a:extLst>
          </p:cNvPr>
          <p:cNvSpPr txBox="1"/>
          <p:nvPr/>
        </p:nvSpPr>
        <p:spPr>
          <a:xfrm>
            <a:off x="8522994" y="139142"/>
            <a:ext cx="336766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WB </a:t>
            </a:r>
          </a:p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Co-IP: FANCJ WT and FANCJ AALA  with 6xHis </a:t>
            </a:r>
            <a:r>
              <a:rPr lang="it-IT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epB</a:t>
            </a:r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pic>
        <p:nvPicPr>
          <p:cNvPr id="5" name="Immagine 4">
            <a:extLst>
              <a:ext uri="{FF2B5EF4-FFF2-40B4-BE49-F238E27FC236}">
                <a16:creationId xmlns:a16="http://schemas.microsoft.com/office/drawing/2014/main" id="{6469885F-9F21-62DB-9502-A8D30F316B8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15000" contrast="-42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024387" y="888385"/>
            <a:ext cx="3886200" cy="2068461"/>
          </a:xfrm>
          <a:prstGeom prst="rect">
            <a:avLst/>
          </a:prstGeom>
        </p:spPr>
      </p:pic>
      <p:sp>
        <p:nvSpPr>
          <p:cNvPr id="9" name="CasellaDiTesto 8">
            <a:extLst>
              <a:ext uri="{FF2B5EF4-FFF2-40B4-BE49-F238E27FC236}">
                <a16:creationId xmlns:a16="http://schemas.microsoft.com/office/drawing/2014/main" id="{14D2A555-46FC-91C0-0FEE-C3F155832FE0}"/>
              </a:ext>
            </a:extLst>
          </p:cNvPr>
          <p:cNvSpPr txBox="1"/>
          <p:nvPr/>
        </p:nvSpPr>
        <p:spPr>
          <a:xfrm>
            <a:off x="6596332" y="4385510"/>
            <a:ext cx="4510530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342900" indent="-342900">
              <a:buAutoNum type="arabicPeriod"/>
            </a:pP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lag-FANCJ WT + 6xHis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epB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(pulled-down sample)</a:t>
            </a:r>
          </a:p>
          <a:p>
            <a:pPr marL="342900" indent="-342900">
              <a:buAutoNum type="arabicPeriod"/>
            </a:pP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lag-FANCJ AALA + 6xHis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epB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(pulled-down sample)</a:t>
            </a:r>
          </a:p>
          <a:p>
            <a:pPr marL="342900" indent="-342900">
              <a:buFontTx/>
              <a:buAutoNum type="arabicPeriod"/>
            </a:pP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6xHis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epB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alone, control (pulled-down sample)</a:t>
            </a:r>
          </a:p>
          <a:p>
            <a:pPr marL="342900" indent="-342900">
              <a:buAutoNum type="arabicPeriod"/>
            </a:pP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</a:p>
        </p:txBody>
      </p:sp>
      <p:sp>
        <p:nvSpPr>
          <p:cNvPr id="10" name="Rettangolo 9">
            <a:extLst>
              <a:ext uri="{FF2B5EF4-FFF2-40B4-BE49-F238E27FC236}">
                <a16:creationId xmlns:a16="http://schemas.microsoft.com/office/drawing/2014/main" id="{AABF3E4B-A3B4-D328-7285-B1E95E7F22EB}"/>
              </a:ext>
            </a:extLst>
          </p:cNvPr>
          <p:cNvSpPr/>
          <p:nvPr/>
        </p:nvSpPr>
        <p:spPr>
          <a:xfrm>
            <a:off x="2370792" y="1605701"/>
            <a:ext cx="1573442" cy="5022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12" name="Immagine 11">
            <a:extLst>
              <a:ext uri="{FF2B5EF4-FFF2-40B4-BE49-F238E27FC236}">
                <a16:creationId xmlns:a16="http://schemas.microsoft.com/office/drawing/2014/main" id="{805EFE82-5B62-CED3-442D-D0E1A7C8378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1000" contrast="7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024387" y="3174622"/>
            <a:ext cx="3886200" cy="2528621"/>
          </a:xfrm>
          <a:prstGeom prst="rect">
            <a:avLst/>
          </a:prstGeom>
        </p:spPr>
      </p:pic>
      <p:sp>
        <p:nvSpPr>
          <p:cNvPr id="11" name="Rettangolo 10">
            <a:extLst>
              <a:ext uri="{FF2B5EF4-FFF2-40B4-BE49-F238E27FC236}">
                <a16:creationId xmlns:a16="http://schemas.microsoft.com/office/drawing/2014/main" id="{F8A8D479-D0F2-F3EE-5E06-36A6119919FD}"/>
              </a:ext>
            </a:extLst>
          </p:cNvPr>
          <p:cNvSpPr/>
          <p:nvPr/>
        </p:nvSpPr>
        <p:spPr>
          <a:xfrm>
            <a:off x="2370791" y="3429000"/>
            <a:ext cx="1407579" cy="36662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609087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</TotalTime>
  <Words>39</Words>
  <Application>Microsoft Macintosh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FRANCESCA MARIA PISANI</dc:creator>
  <cp:lastModifiedBy>FRANCESCA MARIA PISANI</cp:lastModifiedBy>
  <cp:revision>1</cp:revision>
  <dcterms:created xsi:type="dcterms:W3CDTF">2023-12-04T11:24:45Z</dcterms:created>
  <dcterms:modified xsi:type="dcterms:W3CDTF">2023-12-04T11:58:02Z</dcterms:modified>
</cp:coreProperties>
</file>